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84" y="92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4959E-47DF-4E7B-B68D-EEF9C3C7F120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F42186-6932-4BA4-A637-FA4300C341C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ig S3 new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0200" y="609600"/>
            <a:ext cx="3821592" cy="350215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4800600"/>
            <a:ext cx="6943567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3: Effects of doxycycline (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) on NF-</a:t>
            </a:r>
            <a:r>
              <a:rPr lang="en-US" dirty="0" err="1" smtClean="0">
                <a:latin typeface="Symbol" pitchFamily="18" charset="2"/>
                <a:cs typeface="Times New Roman" pitchFamily="18" charset="0"/>
              </a:rPr>
              <a:t>k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activity. HEK293 </a:t>
            </a:r>
          </a:p>
          <a:p>
            <a:pPr algn="just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cells in 12-well plates were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ransfected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with 1</a:t>
            </a:r>
            <a:r>
              <a:rPr lang="en-US" dirty="0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g/well of NF-</a:t>
            </a:r>
            <a:r>
              <a:rPr lang="en-US" dirty="0" err="1" smtClean="0">
                <a:latin typeface="Symbol" pitchFamily="18" charset="2"/>
                <a:cs typeface="Times New Roman" pitchFamily="18" charset="0"/>
              </a:rPr>
              <a:t>k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pPr algn="just"/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Luciferas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reporter and 20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ng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/well of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Renilla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luciferas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vectors. </a:t>
            </a:r>
          </a:p>
          <a:p>
            <a:pPr algn="just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orty-eight hours after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ransfection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, cells were serum-starved for 1 h </a:t>
            </a:r>
          </a:p>
          <a:p>
            <a:pPr algn="just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ollowed with stimulation by 20ng/ml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NF</a:t>
            </a:r>
            <a:r>
              <a:rPr lang="en-US" dirty="0" err="1" smtClean="0">
                <a:latin typeface="Symbol" pitchFamily="18" charset="2"/>
                <a:cs typeface="Times New Roman" pitchFamily="18" charset="0"/>
              </a:rPr>
              <a:t>a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for 4 h. To determine the </a:t>
            </a:r>
          </a:p>
          <a:p>
            <a:pPr algn="just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effects of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, cells were pre-treated with 5</a:t>
            </a:r>
            <a:r>
              <a:rPr lang="en-US" dirty="0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g/ml of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for 24 h before</a:t>
            </a:r>
          </a:p>
          <a:p>
            <a:pPr algn="just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timulation.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was included during the stimulation by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NF</a:t>
            </a:r>
            <a:r>
              <a:rPr lang="en-US" dirty="0" err="1" smtClean="0">
                <a:latin typeface="Symbol" pitchFamily="18" charset="2"/>
                <a:cs typeface="Times New Roman" pitchFamily="18" charset="0"/>
              </a:rPr>
              <a:t>a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. </a:t>
            </a:r>
          </a:p>
          <a:p>
            <a:pPr algn="just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Luminescence were measured by Dual-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Luciferas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Reporter Assay </a:t>
            </a:r>
          </a:p>
          <a:p>
            <a:pPr algn="just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ystem (E1910) of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Promega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using the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Microbeta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1450 plate reader from </a:t>
            </a:r>
          </a:p>
          <a:p>
            <a:pPr algn="just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erkin Elmer.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* p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&lt;0.05 relative to cells without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treatment. Results </a:t>
            </a:r>
          </a:p>
          <a:p>
            <a:pPr algn="just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were analyzed by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ANOVA with an SNK post </a:t>
            </a:r>
            <a:r>
              <a:rPr lang="en-US" smtClean="0">
                <a:latin typeface="Times New Roman" pitchFamily="18" charset="0"/>
                <a:cs typeface="Times New Roman" pitchFamily="18" charset="0"/>
              </a:rPr>
              <a:t>hoc test.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52</Words>
  <Application>Microsoft Macintosh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iaoyun</dc:creator>
  <cp:lastModifiedBy>David Brindley</cp:lastModifiedBy>
  <cp:revision>7</cp:revision>
  <dcterms:created xsi:type="dcterms:W3CDTF">2017-01-02T22:35:27Z</dcterms:created>
  <dcterms:modified xsi:type="dcterms:W3CDTF">2017-01-04T23:33:27Z</dcterms:modified>
</cp:coreProperties>
</file>